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D966"/>
    <a:srgbClr val="595959"/>
    <a:srgbClr val="F2F2F2"/>
    <a:srgbClr val="7F7F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17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D39073-7C71-43E1-8438-661071F86384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597874-2232-4A86-8E92-89CDD8DE06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50878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597874-2232-4A86-8E92-89CDD8DE0604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40792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ED1835C-98C6-4343-B010-F055FA9AE8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4809DC8-A3A1-46DE-B708-BCAE1942DF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AC566D0-BD39-43D2-9B6C-0A2C3E8B3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9608EE0-B666-4D3A-91A7-E1201B8A9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65D5A5F-00EE-4956-97B9-F6492F848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0621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82EAB29-860F-4461-A33C-283D2BE6A0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B616B93-241A-4812-9D19-68CB69E7DB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333B67-5093-4A44-9042-1538456FC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A5D6AD6-F6D9-4F2C-A16E-93C8B9EDA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1D1CFE4-42C3-458D-9622-4372CC85B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9392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054FE52-BBF0-4973-813A-B0C13A034F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E2234E0-D23C-4874-863C-74E2896F10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649D17C-2AF3-40FB-99D0-F912E7CA6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595452D-8ED9-4B76-A7C5-7ED9D3CDD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D52D163-1EDB-4FB5-8EF1-629620601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5759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0322EB-4E06-477C-AA82-1A2151BB57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0E6B8FE-B5C9-4D7A-8C10-1D4562ADB9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50E6A77-CBE7-479E-B6D3-779663527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1B006C-E5C6-4BF0-94FF-490211142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4F6C7E9-09FE-4C92-B7E9-C57F69F6C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0625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932E1F9-FD75-4276-8DB5-87F4073E5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1561EAF-9A55-4B0D-91A8-B6CF5823BF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0E38CE-7BCD-44A5-AA12-C9F849CD8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10EDFB8-9678-42C3-B556-814FD3B07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1FC8C5-9CFC-407B-824C-EBFE906FD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7161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6040FF6-40B6-400B-93A1-237EA76D85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27E15B1-079E-44C0-AEFF-C3DC35E78E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D5FB2D0-9750-4BB0-9681-32A6F33836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D96B451-C0FA-4C90-B240-7C3B06FC0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E2C219B-142E-463C-9138-82988B034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72B70C2-FEC0-439A-9755-C336BB073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8441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BE3851C-C314-441C-A700-A37D7879B7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409A3DB-C1EF-4FBA-A9A0-5BA951573C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F2CF0D8-6B9D-4B1D-9A04-27C8FAD75C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2690FAD1-6280-43B4-B957-F423B0F686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B396CFB-24D6-4551-A417-D25647421A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CE10720-8DED-4F7A-89A8-39EEE4F5F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3F41D33-20D1-4715-AA34-C6C4FF3F5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A27EF59D-0E57-4C04-A54B-804216CE1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780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7E7AA68-E6EF-4276-9590-B61A4B170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40A9C40-3825-45ED-9671-3B5F0F2E3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7D2129D-E136-4420-A97F-8DABAA751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AAEB838-790E-481A-AF16-813012D00F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8830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5880233-36A8-486C-9FF9-20998602F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A98BB53-9398-4AEC-8309-62D445F81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801B8A42-F963-4CB4-A60D-78D7220AD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1032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AAF76CC-E7B1-4BAC-8AA9-BA6E7A4264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7A940D3-1FFB-4CB0-B405-35302B4A39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B0BB109-60CE-4ECD-90DA-F402534F5B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6C586AA-CE3A-43A1-9BF1-E6B3E06CC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3E03023-7DA8-4D70-BB71-0269DFB0D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AD33BCA-5A68-440C-B5A7-14186B5F3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086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5C5BFEE-6FD1-4647-BD35-BC07841D1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815D3F5-C006-489C-84F1-46372DA362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1FFCA76-035A-45C8-99BF-483D8C1267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4DE93E9-3E1D-4647-AEB2-614A080B9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5F4A9A6-8CE4-4814-85E4-5F80D4E69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5EE3B0E-BE8C-4941-86BF-213C92112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9772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8FC9BDB-B835-4E3E-AD62-9F166D64A4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73B7E0E-F1C4-4AE4-9958-92CE9A47D8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63BF99C-8C9F-4945-B392-476E050783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E857DE-EF36-4A3A-A1C6-446C5BA949CC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470DEDE-F30E-4A33-8E5C-5017A97B47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22C5CA0-54E3-4302-99F5-1078795C62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53231-F371-4567-9BAA-9F2B240B35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9613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A4F525B9-BC56-4A66-98B9-81252DCEA47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0022" y="1136896"/>
            <a:ext cx="5583955" cy="4584207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D3B3F281-72A9-471C-85E0-07E0635A10E2}"/>
              </a:ext>
            </a:extLst>
          </p:cNvPr>
          <p:cNvSpPr/>
          <p:nvPr/>
        </p:nvSpPr>
        <p:spPr>
          <a:xfrm>
            <a:off x="0" y="6442456"/>
            <a:ext cx="9144000" cy="398229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6. Schematic of the genetic interactions between I locus and T locus, and expected phenotypes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ach color denotes actual phenotypes in the corresponding tissues, except for the white, which represents independent inheritance in corresponding part of the tissues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4608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8</TotalTime>
  <Words>46</Words>
  <Application>Microsoft Office PowerPoint</Application>
  <PresentationFormat>화면 슬라이드 쇼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진현 김</dc:creator>
  <cp:lastModifiedBy>김 진현</cp:lastModifiedBy>
  <cp:revision>28</cp:revision>
  <dcterms:created xsi:type="dcterms:W3CDTF">2019-05-23T06:05:07Z</dcterms:created>
  <dcterms:modified xsi:type="dcterms:W3CDTF">2020-04-24T15:39:26Z</dcterms:modified>
</cp:coreProperties>
</file>